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86395"/>
  </p:normalViewPr>
  <p:slideViewPr>
    <p:cSldViewPr snapToGrid="0" snapToObjects="1">
      <p:cViewPr varScale="1">
        <p:scale>
          <a:sx n="100" d="100"/>
          <a:sy n="100" d="100"/>
        </p:scale>
        <p:origin x="245" y="67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37C97B-FDED-554A-88A9-AD132EFBCAC0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8C1ABC-A3D2-5E4A-B5D4-CAC042D73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273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8C1ABC-A3D2-5E4A-B5D4-CAC042D73B1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773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5E2362-CCCF-0041-92D1-E4162323A4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1D66E2-06B6-A848-8A75-5A7C6C277C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ADF4DE-B1FD-6C47-8269-5BCA505B7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34844-3DA7-3442-8AC2-C6EE98C90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10C21D-9843-F44E-84A4-3E63568C5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050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BAF5E-BF3F-7D4B-AE71-22B6BDB161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D796EC-DEAA-7144-8792-F3FB2BE647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032E38-C054-454B-A2F8-9D0D538BD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C51EB0-2B05-F748-BC74-056312378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D9CFB8-33B5-3A4D-889B-D3053D23F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987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259695-EB6D-CC44-9BAC-66861B8F01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572226-31BF-FC4A-9819-E1B5A6D650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4D0CA-A6B3-B34B-B22A-C0B5CCB36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EAA1D4-4817-8648-98CA-674E347D6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8119CD-37AE-CE48-9D83-502D99D3E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780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036978-AC07-BE4E-B42B-09E02B1CAE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FF0574-D046-7A47-9729-66AEB31941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5533A6-F42C-0949-922E-1C9533544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EA0BD3-0EC6-5644-B09D-60D4A3D1E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C0E8EE-B8AE-784E-984A-C82FCEC3E7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302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02AB98-FD85-0741-875D-72B63ED4A5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D0800E-B407-B94F-A48A-1EA670CA16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C08603-CFA6-C34C-94EB-A9CA8D9C1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1E2BD1-1316-724D-BD87-8349607DB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EF613B-914A-DA4D-9F03-727378B70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246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AB925-D792-2445-8163-C36827BCB8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5F8F3E-4757-744A-A26C-84CA45BF80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A5CB31-966B-1C40-A4AE-3014B7E943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CC04F7-E377-AF44-A9B0-82AF76D3F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76A7F2-E0DC-5646-8AE8-CB06AEEAD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5D9DC2-7B0E-5742-B2FB-DD34AE739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623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01820-B052-FF41-B221-465A845D64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10CE75-7A9B-6F4B-9C56-5EFAACAEDE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63ED5D-13E2-0E47-B36E-F1C1CC318A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DACE01-5FA0-B541-B45E-96ED915300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1C39F3-91FE-994D-992F-DB7D4EBBDD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F132D02-CD92-E84F-9717-40738E1FD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080CA1D-1D37-0748-80E5-40A6E2968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F71C993-15B1-1B45-A56D-CA88B0D3C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001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44100-A0AF-6148-AF1B-7AD90D274A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92A76C-34E3-FB43-9646-A99796FCF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0ECCEE4-368E-144D-A60C-4AAA54C7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409372-91F4-1347-A533-898BF58C1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191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0C4006-5ABE-3341-B11B-8EE4A410D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C62C924-9791-F94B-8607-C2E9301CC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025599-87C0-8147-9DAD-BCA7ECCCC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461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426611-B25A-084A-B324-C86A73FFF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E5343E-8579-1F43-9473-B665F184C7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0B89B4-81EA-0648-84AA-F2B3E8787B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A9D321-AB2B-FA43-90BC-175111E15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931052-9E43-7D43-AF45-C68117D73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CA13BE-B2AA-D245-B76F-0694AA5DA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047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EC996-CE10-744D-ACF6-48B0BB83AD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C670106-11DE-EA48-9371-69118E7873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11AEE9-A70C-2949-B934-1B2321C6D0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8C48ED-73A3-6544-85CE-6118A648B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5816E2-8E10-0F41-9A3D-9C3E4DFA4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01D554-6B23-1643-96D9-F6147E95F1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056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1641F2-72D9-394B-8BEB-4B4F4FFE1A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ED87D6-2DED-B646-B5DE-98FAC68373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3D9555-B477-BC4C-8D8F-2DFB3C7FDB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C14FB3-D185-C94D-B0CA-6C8EDAFC5FB7}" type="datetimeFigureOut">
              <a:rPr lang="en-US" smtClean="0"/>
              <a:t>3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9956C8-564E-A546-9EE6-8702D98C49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4E39AA-11ED-9949-8EFD-33F6B035A9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361A8-0BCE-DE4B-8A5D-A74C56866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23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64F7700-07CA-A547-BCC5-903851D65BB8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2210829" y="1041342"/>
            <a:ext cx="7584989" cy="4813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0B42E10-4F13-834F-8E79-60B6EB3E4ACD}"/>
              </a:ext>
            </a:extLst>
          </p:cNvPr>
          <p:cNvSpPr txBox="1"/>
          <p:nvPr/>
        </p:nvSpPr>
        <p:spPr>
          <a:xfrm>
            <a:off x="2106752" y="5854342"/>
            <a:ext cx="7793141" cy="5419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tabLst>
                <a:tab pos="457200" algn="l"/>
              </a:tabLst>
            </a:pPr>
            <a:r>
              <a:rPr lang="en-US" sz="14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Zip codes including 21205, 21206, 21212, 21213, 21218, 21224, 21231, 21239. X is the approximate location of Johns Hopkins Hospital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4A55ABB-6249-BC4E-BDAA-DA1FE6163C57}"/>
              </a:ext>
            </a:extLst>
          </p:cNvPr>
          <p:cNvSpPr txBox="1"/>
          <p:nvPr/>
        </p:nvSpPr>
        <p:spPr>
          <a:xfrm>
            <a:off x="2106751" y="667265"/>
            <a:ext cx="7944029" cy="3886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1: </a:t>
            </a:r>
            <a:r>
              <a:rPr lang="en-US" sz="18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gh-risk zip codes in East Baltimore </a:t>
            </a:r>
            <a:endParaRPr lang="en-US" sz="16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3814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9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ulanger, Mary</dc:creator>
  <cp:lastModifiedBy>MDPI</cp:lastModifiedBy>
  <cp:revision>15</cp:revision>
  <dcterms:created xsi:type="dcterms:W3CDTF">2023-09-28T16:46:39Z</dcterms:created>
  <dcterms:modified xsi:type="dcterms:W3CDTF">2024-03-07T02:53:32Z</dcterms:modified>
</cp:coreProperties>
</file>